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  <p:sldId id="264" r:id="rId3"/>
    <p:sldId id="259" r:id="rId4"/>
    <p:sldId id="260" r:id="rId5"/>
    <p:sldId id="261" r:id="rId6"/>
    <p:sldId id="262" r:id="rId7"/>
    <p:sldId id="263" r:id="rId8"/>
    <p:sldId id="265" r:id="rId9"/>
    <p:sldId id="266" r:id="rId10"/>
    <p:sldId id="267" r:id="rId11"/>
    <p:sldId id="268" r:id="rId12"/>
    <p:sldId id="269" r:id="rId13"/>
    <p:sldId id="270" r:id="rId14"/>
    <p:sldId id="271" r:id="rId15"/>
    <p:sldId id="272" r:id="rId16"/>
    <p:sldId id="273" r:id="rId17"/>
    <p:sldId id="274" r:id="rId18"/>
    <p:sldId id="275" r:id="rId19"/>
    <p:sldId id="276" r:id="rId20"/>
    <p:sldId id="277" r:id="rId21"/>
    <p:sldId id="278" r:id="rId22"/>
    <p:sldId id="279" r:id="rId23"/>
    <p:sldId id="280" r:id="rId24"/>
    <p:sldId id="281" r:id="rId25"/>
    <p:sldId id="282" r:id="rId26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755"/>
  </p:normalViewPr>
  <p:slideViewPr>
    <p:cSldViewPr snapToGrid="0">
      <p:cViewPr varScale="1">
        <p:scale>
          <a:sx n="110" d="100"/>
          <a:sy n="110" d="100"/>
        </p:scale>
        <p:origin x="632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presProps" Target="presProps.xml"/><Relationship Id="rId30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A550F1F-23B0-F0CC-051E-13FA54CB455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4D9D7156-E0BB-47DA-8F31-6E8A4F857FA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7769EF8-3A73-C45D-EB4F-B7D50015D0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8C929-8DCE-1549-8C14-0DD533E7C42E}" type="datetimeFigureOut">
              <a:rPr lang="de-DE" smtClean="0"/>
              <a:t>14.03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E99F8A5-265A-4113-589B-91DD576F32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203CA4D-0D1E-6C0D-3C8E-67B661665E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7A4E9E-FB87-104B-B667-051D510AD04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383556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2276E20-E70C-391E-D0A0-8052186DBA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60FA83DE-EA3A-742E-83A4-827D0DFB46E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C472A2A-A6E0-D687-D031-9EAD8D1CC1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8C929-8DCE-1549-8C14-0DD533E7C42E}" type="datetimeFigureOut">
              <a:rPr lang="de-DE" smtClean="0"/>
              <a:t>14.03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0F7912B-AD34-B164-C443-623DFC90BE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84C484B-F97C-06F2-C9BC-7313DAF9DD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7A4E9E-FB87-104B-B667-051D510AD04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15915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10717E40-44EE-9938-821B-5BA36031197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1873745A-0345-1DC4-4A7A-358EC6D8D5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6C3F139-A902-355C-816F-B97B3B333E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8C929-8DCE-1549-8C14-0DD533E7C42E}" type="datetimeFigureOut">
              <a:rPr lang="de-DE" smtClean="0"/>
              <a:t>14.03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5FB8A33-9DED-9376-CF57-C8C4A137BC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DCF6465-115A-A14E-7F24-38295E7F32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7A4E9E-FB87-104B-B667-051D510AD04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913648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63686CD-A38A-017E-32E3-FE7F38D518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E87A37C4-200E-45C9-7E43-8CDFB5015AB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32ED697-D29D-6DA2-33A8-EF1CB25C92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8C929-8DCE-1549-8C14-0DD533E7C42E}" type="datetimeFigureOut">
              <a:rPr lang="de-DE" smtClean="0"/>
              <a:t>14.03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922EEB8-09C7-3D58-1C44-2A51155BF8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7239287-8515-CB8B-57B2-8289A51B82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7A4E9E-FB87-104B-B667-051D510AD04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129323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D5506A6-0DF4-8DCB-27A6-999FC5D81F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A0793FC1-27E3-6B24-5F47-9EA9FF2CC2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A3276D1-8B81-2A57-D3B7-172F9A6CCC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8C929-8DCE-1549-8C14-0DD533E7C42E}" type="datetimeFigureOut">
              <a:rPr lang="de-DE" smtClean="0"/>
              <a:t>14.03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4E183C5C-3813-595A-8231-30682C411A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BF6F899-0889-59F1-3B93-9523654476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7A4E9E-FB87-104B-B667-051D510AD04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221944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7BAAEB6-C1DC-A463-606E-4C2042E964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6E58F843-F557-3EFF-51A4-DFCC948AB68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DCF6DC6E-F478-5C53-BCC6-2C57491810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043CD6F1-992E-1B42-2A64-502964741C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8C929-8DCE-1549-8C14-0DD533E7C42E}" type="datetimeFigureOut">
              <a:rPr lang="de-DE" smtClean="0"/>
              <a:t>14.03.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74328AFE-3DEB-0559-BEBB-48DAB92A49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31124B32-0148-DD4B-D634-48454FCAD6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7A4E9E-FB87-104B-B667-051D510AD04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585131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E366C45-5DE0-6824-1F75-F05FC41F23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97D9BD03-27C6-C873-A3B2-CEB68481D8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E7688628-A6ED-6BAA-4F5E-0F2FCF6E28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6BAB0967-4310-1703-E39E-F3CAF11DDBA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8BEF8D60-E376-1624-9714-F8AE3ADC0A8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BA4671AF-3C15-8463-7216-D0E2698E33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8C929-8DCE-1549-8C14-0DD533E7C42E}" type="datetimeFigureOut">
              <a:rPr lang="de-DE" smtClean="0"/>
              <a:t>14.03.24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5857DCA8-48E3-1A03-BC25-AB7663A529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00A6FA2F-BC2D-9AF7-C658-8886473793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7A4E9E-FB87-104B-B667-051D510AD04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117753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8DDDF8B-4184-D141-0AD3-A861282A0C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21690250-E949-37A8-77E4-8567A6462A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8C929-8DCE-1549-8C14-0DD533E7C42E}" type="datetimeFigureOut">
              <a:rPr lang="de-DE" smtClean="0"/>
              <a:t>14.03.24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204C769C-9A90-0DA2-3DBF-DAFDD69B33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01146828-8047-8A02-CE23-19E21C6762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7A4E9E-FB87-104B-B667-051D510AD04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978716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B269B080-5AEE-8E71-103A-0041B7F9D2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8C929-8DCE-1549-8C14-0DD533E7C42E}" type="datetimeFigureOut">
              <a:rPr lang="de-DE" smtClean="0"/>
              <a:t>14.03.24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8469B9D1-21B7-0CA5-9E6A-E5DF07DCEF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B18A92FA-A0B0-17A9-A298-D28E02A6DA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7A4E9E-FB87-104B-B667-051D510AD04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852402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E4D0DE2-4F1E-69BD-53A1-0F71E4E677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BF37EFC1-A6FE-818B-8264-F86DA45E9AB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03AC1949-5611-175B-1B08-53F6D122649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E5AFA736-887B-B229-CDE1-F55E21EB43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8C929-8DCE-1549-8C14-0DD533E7C42E}" type="datetimeFigureOut">
              <a:rPr lang="de-DE" smtClean="0"/>
              <a:t>14.03.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4D13CDDD-FCAE-FE6B-57AA-E2CDF8B996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FEF8BB14-68D7-7844-1D73-05AC48767B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7A4E9E-FB87-104B-B667-051D510AD04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282338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4B2D487-F145-BFF8-74C3-97CEE4C6EF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70B8A264-9D99-7B3A-560A-41C5AA22CC1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BF4F3D49-C0FB-969D-47FE-4FBC13F1F07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DC10A7F1-ABA5-89E4-99A5-D45B3C7B9A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8C929-8DCE-1549-8C14-0DD533E7C42E}" type="datetimeFigureOut">
              <a:rPr lang="de-DE" smtClean="0"/>
              <a:t>14.03.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761DC633-8C3D-F59E-6C91-CEDC86E6FB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ED9FA024-DE55-1D62-BAA2-781119E9B9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7A4E9E-FB87-104B-B667-051D510AD04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03719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CAE8ABC8-C080-6D1F-DD7F-A044C9FD90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3D1D6350-9772-E283-3FD3-F8E40DCD29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E2576DD-5A21-93B7-E1AE-AFB32FA534E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58C929-8DCE-1549-8C14-0DD533E7C42E}" type="datetimeFigureOut">
              <a:rPr lang="de-DE" smtClean="0"/>
              <a:t>14.03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F0A98CB-16F1-A270-7607-3416B90145F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28337C2-C8CE-DDB7-A891-511EF822237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7A4E9E-FB87-104B-B667-051D510AD04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533091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JP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JPG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JPG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JPG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JPG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JPG"/><Relationship Id="rId2" Type="http://schemas.openxmlformats.org/officeDocument/2006/relationships/image" Target="../media/image23.JPG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 descr="Ein Bild, das gelb enthält.&#10;&#10;Automatisch generierte Beschreibung mit mittlerer Zuverlässigkeit">
            <a:extLst>
              <a:ext uri="{FF2B5EF4-FFF2-40B4-BE49-F238E27FC236}">
                <a16:creationId xmlns:a16="http://schemas.microsoft.com/office/drawing/2014/main" id="{9C72B2AA-F55C-F1DE-23C0-4AE24FDE920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97225" y="530225"/>
            <a:ext cx="5797550" cy="5797550"/>
          </a:xfrm>
          <a:prstGeom prst="rect">
            <a:avLst/>
          </a:prstGeom>
        </p:spPr>
      </p:pic>
      <p:sp>
        <p:nvSpPr>
          <p:cNvPr id="6" name="Textfeld 5">
            <a:extLst>
              <a:ext uri="{FF2B5EF4-FFF2-40B4-BE49-F238E27FC236}">
                <a16:creationId xmlns:a16="http://schemas.microsoft.com/office/drawing/2014/main" id="{6283E244-79C9-10F4-E5C5-C9893670EDF6}"/>
              </a:ext>
            </a:extLst>
          </p:cNvPr>
          <p:cNvSpPr txBox="1"/>
          <p:nvPr/>
        </p:nvSpPr>
        <p:spPr>
          <a:xfrm>
            <a:off x="0" y="6379501"/>
            <a:ext cx="12192000" cy="4648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SM-Fig. 1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Gelatine 10 % by mass (thickness 0.3 cm, perpendicular shot, 10 m distance) </a:t>
            </a:r>
            <a:endParaRPr lang="de-DE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6812599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C2E8BE8-8EBA-52BF-5231-DB7CD5B29BE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>
            <a:extLst>
              <a:ext uri="{FF2B5EF4-FFF2-40B4-BE49-F238E27FC236}">
                <a16:creationId xmlns:a16="http://schemas.microsoft.com/office/drawing/2014/main" id="{AC0E1CFC-9797-1E12-A3B7-B7B25F3D0BAA}"/>
              </a:ext>
            </a:extLst>
          </p:cNvPr>
          <p:cNvSpPr txBox="1"/>
          <p:nvPr/>
        </p:nvSpPr>
        <p:spPr>
          <a:xfrm>
            <a:off x="0" y="6379501"/>
            <a:ext cx="12192000" cy="4648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SM-Fig. 10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Gelatine 60 % by mass (thickness 0.3 cm, perpendicular shot, 10 m distance)  </a:t>
            </a:r>
            <a:endParaRPr lang="de-DE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Grafik 2" descr="Ein Bild, das Wirbellose, Insekt, gelb enthält.&#10;&#10;Automatisch generierte Beschreibung">
            <a:extLst>
              <a:ext uri="{FF2B5EF4-FFF2-40B4-BE49-F238E27FC236}">
                <a16:creationId xmlns:a16="http://schemas.microsoft.com/office/drawing/2014/main" id="{D50D3801-192B-FF4D-5615-AFBB8851C49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09269" y="1642269"/>
            <a:ext cx="3573462" cy="35734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4690906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FC1AEF7-1CAC-7B3C-88EB-8860F417DA8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>
            <a:extLst>
              <a:ext uri="{FF2B5EF4-FFF2-40B4-BE49-F238E27FC236}">
                <a16:creationId xmlns:a16="http://schemas.microsoft.com/office/drawing/2014/main" id="{712ADF67-8B91-24A5-BDF6-08AD9B799B64}"/>
              </a:ext>
            </a:extLst>
          </p:cNvPr>
          <p:cNvSpPr txBox="1"/>
          <p:nvPr/>
        </p:nvSpPr>
        <p:spPr>
          <a:xfrm>
            <a:off x="0" y="6379501"/>
            <a:ext cx="12192000" cy="4648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SM-Fig. 11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Gelatine 60 % by mass (thickness 0.6 cm, oblique shot, 0.3 m distance)</a:t>
            </a:r>
            <a:endParaRPr lang="de-DE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Grafik 3" descr="Ein Bild, das gelb enthält.&#10;&#10;Automatisch generierte Beschreibung">
            <a:extLst>
              <a:ext uri="{FF2B5EF4-FFF2-40B4-BE49-F238E27FC236}">
                <a16:creationId xmlns:a16="http://schemas.microsoft.com/office/drawing/2014/main" id="{212059FE-C62D-6A24-DF8B-27B4AED260B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016374" y="1349374"/>
            <a:ext cx="4159251" cy="41592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7105855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309AB77-2497-987A-89D5-AC9840688BA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>
            <a:extLst>
              <a:ext uri="{FF2B5EF4-FFF2-40B4-BE49-F238E27FC236}">
                <a16:creationId xmlns:a16="http://schemas.microsoft.com/office/drawing/2014/main" id="{703A491A-91BB-BFEB-33D7-5376D52E86E4}"/>
              </a:ext>
            </a:extLst>
          </p:cNvPr>
          <p:cNvSpPr txBox="1"/>
          <p:nvPr/>
        </p:nvSpPr>
        <p:spPr>
          <a:xfrm>
            <a:off x="0" y="6379501"/>
            <a:ext cx="12192000" cy="4648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SM-Fig. 12 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ental silicone shore hardness 16 (thickness 0.6 cm, perpendicular shot, 10 m distance)   </a:t>
            </a:r>
            <a:endParaRPr lang="de-DE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7" name="Grafik 6">
            <a:extLst>
              <a:ext uri="{FF2B5EF4-FFF2-40B4-BE49-F238E27FC236}">
                <a16:creationId xmlns:a16="http://schemas.microsoft.com/office/drawing/2014/main" id="{7FA2C125-2203-2B1C-208B-F5B05E3AFAF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03163" y="1736163"/>
            <a:ext cx="3385674" cy="33856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9022359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56F36FC-9D48-11FD-448D-2FB48FABA4D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EEC143C1-2D07-454C-EAB8-A3CEFD482907}"/>
              </a:ext>
            </a:extLst>
          </p:cNvPr>
          <p:cNvSpPr txBox="1"/>
          <p:nvPr/>
        </p:nvSpPr>
        <p:spPr>
          <a:xfrm>
            <a:off x="0" y="6379501"/>
            <a:ext cx="12192000" cy="4648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SM-Fig. 13 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ental silicone shore hardness 22 (thickness 0.05 cm, perpendicular shot, 0.3 m distance)   </a:t>
            </a:r>
            <a:endParaRPr lang="de-DE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8" name="Grafik 7" descr="Ein Bild, das gelb enthält.&#10;&#10;Automatisch generierte Beschreibung">
            <a:extLst>
              <a:ext uri="{FF2B5EF4-FFF2-40B4-BE49-F238E27FC236}">
                <a16:creationId xmlns:a16="http://schemas.microsoft.com/office/drawing/2014/main" id="{2EF72E92-900C-58C2-0D94-8B76C133881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6589" r="26931" b="10362"/>
          <a:stretch/>
        </p:blipFill>
        <p:spPr>
          <a:xfrm>
            <a:off x="3073398" y="335888"/>
            <a:ext cx="6045203" cy="60436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3840786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D44AA35-07EF-ADAD-474E-DBB521D7CF0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432AEE51-7749-A9F7-FF9D-3794F5CA3045}"/>
              </a:ext>
            </a:extLst>
          </p:cNvPr>
          <p:cNvSpPr txBox="1"/>
          <p:nvPr/>
        </p:nvSpPr>
        <p:spPr>
          <a:xfrm>
            <a:off x="0" y="6379501"/>
            <a:ext cx="12192000" cy="4648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SM-Fig. 14 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ental silicone shore hardness 32 (thickness 0.6 cm, perpendicular shot, 10 m distance) </a:t>
            </a:r>
            <a:endParaRPr lang="de-DE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7" name="Grafik 6">
            <a:extLst>
              <a:ext uri="{FF2B5EF4-FFF2-40B4-BE49-F238E27FC236}">
                <a16:creationId xmlns:a16="http://schemas.microsoft.com/office/drawing/2014/main" id="{F8E1AD34-80A5-79A4-EFAA-5430B7ACBF7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73190" y="1906190"/>
            <a:ext cx="3045619" cy="30456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9814853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2A3BBF3-D1AD-266F-9990-A4B121D65F5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D8E63977-5770-6468-C3F5-C20046F7AA61}"/>
              </a:ext>
            </a:extLst>
          </p:cNvPr>
          <p:cNvSpPr txBox="1"/>
          <p:nvPr/>
        </p:nvSpPr>
        <p:spPr>
          <a:xfrm>
            <a:off x="0" y="6379501"/>
            <a:ext cx="12192000" cy="4648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SM-Fig. 15 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ental silicone shore hardness 60 (thickness 0.3 cm, perpendicular shot, 10 m distance)   </a:t>
            </a:r>
            <a:endParaRPr lang="de-DE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6" name="Grafik 5">
            <a:extLst>
              <a:ext uri="{FF2B5EF4-FFF2-40B4-BE49-F238E27FC236}">
                <a16:creationId xmlns:a16="http://schemas.microsoft.com/office/drawing/2014/main" id="{CC7EFDFC-8BC3-7853-7C1D-8C4C2599190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59659" y="1592659"/>
            <a:ext cx="3672682" cy="36726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12030666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B6EABF8-EA80-351C-D159-0007F74C7E9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E7793ADD-0DC0-9F5F-3B4A-574C62EA4F40}"/>
              </a:ext>
            </a:extLst>
          </p:cNvPr>
          <p:cNvSpPr txBox="1"/>
          <p:nvPr/>
        </p:nvSpPr>
        <p:spPr>
          <a:xfrm>
            <a:off x="0" y="6379501"/>
            <a:ext cx="12192000" cy="4648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SM-Fig. 16 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ental silicone shore hardness 70 (thickness 0.</a:t>
            </a:r>
            <a:r>
              <a:rPr lang="en-US" sz="18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5 cm, oblique shot, 10 m distance)   </a:t>
            </a:r>
            <a:endParaRPr lang="de-DE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7" name="Grafik 6" descr="Ein Bild, das Lineal, Messstab Maßband enthält.&#10;&#10;Automatisch generierte Beschreibung">
            <a:extLst>
              <a:ext uri="{FF2B5EF4-FFF2-40B4-BE49-F238E27FC236}">
                <a16:creationId xmlns:a16="http://schemas.microsoft.com/office/drawing/2014/main" id="{68D104A1-D1D2-94D4-BD94-6DD4448C0AA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37781" y="1170781"/>
            <a:ext cx="4516438" cy="45164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4066976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88CFD85-9A5D-2BCA-D5AE-23B75795C39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6E483BF9-A4F0-67B5-EDCF-99880E509727}"/>
              </a:ext>
            </a:extLst>
          </p:cNvPr>
          <p:cNvSpPr txBox="1"/>
          <p:nvPr/>
        </p:nvSpPr>
        <p:spPr>
          <a:xfrm>
            <a:off x="0" y="6379501"/>
            <a:ext cx="12192000" cy="4648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SM-Fig. 17 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ental silicone shore hardness 85 (thickness 0.</a:t>
            </a:r>
            <a:r>
              <a:rPr lang="en-US" sz="18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5 cm, perpendicular shot, 10 m distance) </a:t>
            </a:r>
            <a:endParaRPr lang="de-DE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8" name="Grafik 7">
            <a:extLst>
              <a:ext uri="{FF2B5EF4-FFF2-40B4-BE49-F238E27FC236}">
                <a16:creationId xmlns:a16="http://schemas.microsoft.com/office/drawing/2014/main" id="{06CBE477-9E8F-1A7B-9778-9F484BF655B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46401" y="1179401"/>
            <a:ext cx="4499198" cy="44991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02626323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76B88E7-F3B5-AC62-C0AA-0388C9400B9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4A909611-DE41-3243-2EC2-2E2D66AC8E29}"/>
              </a:ext>
            </a:extLst>
          </p:cNvPr>
          <p:cNvSpPr txBox="1"/>
          <p:nvPr/>
        </p:nvSpPr>
        <p:spPr>
          <a:xfrm>
            <a:off x="0" y="6379501"/>
            <a:ext cx="12192000" cy="4648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SM-Fig. 18 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ental silicone shore hardness 70-artificial leather-compound (perpendicular shot, 10 m distance)</a:t>
            </a:r>
            <a:endParaRPr lang="de-DE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6" name="Grafik 5">
            <a:extLst>
              <a:ext uri="{FF2B5EF4-FFF2-40B4-BE49-F238E27FC236}">
                <a16:creationId xmlns:a16="http://schemas.microsoft.com/office/drawing/2014/main" id="{D7896A5E-DE3A-5AB2-F6BC-CB407ECEB38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78449" y="1911449"/>
            <a:ext cx="3035102" cy="30351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46173340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B96A7E3-C984-9DD8-5C84-50CDCA429DF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9324283C-F8C5-69AD-8900-96507ACCDCD1}"/>
              </a:ext>
            </a:extLst>
          </p:cNvPr>
          <p:cNvSpPr txBox="1"/>
          <p:nvPr/>
        </p:nvSpPr>
        <p:spPr>
          <a:xfrm>
            <a:off x="0" y="6379501"/>
            <a:ext cx="12192000" cy="4648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SM-Fig. 19 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ental silicone shore hardness 70-artificial leather-compound (oblique shot, 10 m distance)   </a:t>
            </a:r>
            <a:endParaRPr lang="de-DE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7" name="Grafik 6">
            <a:extLst>
              <a:ext uri="{FF2B5EF4-FFF2-40B4-BE49-F238E27FC236}">
                <a16:creationId xmlns:a16="http://schemas.microsoft.com/office/drawing/2014/main" id="{5BAE6C5A-AC19-32A6-E496-B463FB9E02A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33068" y="1566068"/>
            <a:ext cx="3725863" cy="37258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10358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9E0B014-0948-4E17-043B-DCCB3C98E00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>
            <a:extLst>
              <a:ext uri="{FF2B5EF4-FFF2-40B4-BE49-F238E27FC236}">
                <a16:creationId xmlns:a16="http://schemas.microsoft.com/office/drawing/2014/main" id="{4048EBBD-79D2-A7BC-BAFD-50AE8E4D55D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84223" y="917223"/>
            <a:ext cx="5023554" cy="5023554"/>
          </a:xfrm>
          <a:prstGeom prst="rect">
            <a:avLst/>
          </a:prstGeom>
        </p:spPr>
      </p:pic>
      <p:sp>
        <p:nvSpPr>
          <p:cNvPr id="2" name="Textfeld 1">
            <a:extLst>
              <a:ext uri="{FF2B5EF4-FFF2-40B4-BE49-F238E27FC236}">
                <a16:creationId xmlns:a16="http://schemas.microsoft.com/office/drawing/2014/main" id="{01A9DCCA-B15E-2E86-4713-E1E91C07E9AB}"/>
              </a:ext>
            </a:extLst>
          </p:cNvPr>
          <p:cNvSpPr txBox="1"/>
          <p:nvPr/>
        </p:nvSpPr>
        <p:spPr>
          <a:xfrm>
            <a:off x="0" y="6379501"/>
            <a:ext cx="12192000" cy="4648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SM-Fig. 2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Gelatine 10 % by mass (thickness 0.6 cm, oblique shot, 0.3 m distance) </a:t>
            </a:r>
            <a:endParaRPr lang="de-DE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24979789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8F8976B-1163-EDEC-D927-7B869CF3F1C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8E840227-DD91-70A8-6175-3DE479C4671F}"/>
              </a:ext>
            </a:extLst>
          </p:cNvPr>
          <p:cNvSpPr txBox="1"/>
          <p:nvPr/>
        </p:nvSpPr>
        <p:spPr>
          <a:xfrm>
            <a:off x="0" y="6379501"/>
            <a:ext cx="12192000" cy="4648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SM-Fig. 20 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ental silicone shore hardness 70-chamois leather-compound (perpendicular shot, 10 m distance)   </a:t>
            </a:r>
            <a:endParaRPr lang="de-DE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7" name="Grafik 6">
            <a:extLst>
              <a:ext uri="{FF2B5EF4-FFF2-40B4-BE49-F238E27FC236}">
                <a16:creationId xmlns:a16="http://schemas.microsoft.com/office/drawing/2014/main" id="{079F2388-9E9E-F1E9-C0B9-00B3A72374C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53744" y="1886744"/>
            <a:ext cx="3084512" cy="30845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60413971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8F7709C-9057-D778-66FF-05D0894125E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7D9100EA-5B37-0EE1-5E1D-C1F1219018F2}"/>
              </a:ext>
            </a:extLst>
          </p:cNvPr>
          <p:cNvSpPr txBox="1"/>
          <p:nvPr/>
        </p:nvSpPr>
        <p:spPr>
          <a:xfrm>
            <a:off x="0" y="6379501"/>
            <a:ext cx="12192000" cy="4648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SM-Fig. 21 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ental silicone shore hardness 22-chamois leather (oblique shot, 10 m distance)   </a:t>
            </a:r>
            <a:endParaRPr lang="de-DE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6" name="Grafik 5" descr="Ein Bild, das Messstab Maßband, Lineal enthält.&#10;&#10;Automatisch generierte Beschreibung">
            <a:extLst>
              <a:ext uri="{FF2B5EF4-FFF2-40B4-BE49-F238E27FC236}">
                <a16:creationId xmlns:a16="http://schemas.microsoft.com/office/drawing/2014/main" id="{6835A71C-0EA4-D2D4-D213-705DFF4E6CA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37818" y="1470818"/>
            <a:ext cx="3916364" cy="39163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70905120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3D4B0A6-7FD7-E8FF-0D9A-A3EC160A8C4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3AA3055B-4A41-2369-1439-12371A53596F}"/>
              </a:ext>
            </a:extLst>
          </p:cNvPr>
          <p:cNvSpPr txBox="1"/>
          <p:nvPr/>
        </p:nvSpPr>
        <p:spPr>
          <a:xfrm>
            <a:off x="0" y="6379501"/>
            <a:ext cx="12192000" cy="4648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SM-Fig. 22 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hamois leather impregnated with Ballistol® (perpendicular shot, 10 m distance)   </a:t>
            </a:r>
            <a:endParaRPr lang="de-DE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7" name="Grafik 6">
            <a:extLst>
              <a:ext uri="{FF2B5EF4-FFF2-40B4-BE49-F238E27FC236}">
                <a16:creationId xmlns:a16="http://schemas.microsoft.com/office/drawing/2014/main" id="{8257DD92-17F9-B62E-EB6D-3BC33A1794C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57700" y="1790700"/>
            <a:ext cx="3276600" cy="3276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28572052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ED0A240-42E6-A78F-8901-5098AA9A337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>
            <a:extLst>
              <a:ext uri="{FF2B5EF4-FFF2-40B4-BE49-F238E27FC236}">
                <a16:creationId xmlns:a16="http://schemas.microsoft.com/office/drawing/2014/main" id="{4342BD9E-C970-58E0-9713-3490720E11B7}"/>
              </a:ext>
            </a:extLst>
          </p:cNvPr>
          <p:cNvSpPr txBox="1"/>
          <p:nvPr/>
        </p:nvSpPr>
        <p:spPr>
          <a:xfrm>
            <a:off x="0" y="6379501"/>
            <a:ext cx="12192000" cy="4648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SM-Fig. 23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Chamois leather, untreated (perpendicular shot, 10 m distance) </a:t>
            </a:r>
            <a:endParaRPr lang="de-DE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Grafik 2" descr="Ein Bild, das Gelände enthält.&#10;&#10;Automatisch generierte Beschreibung mit mittlerer Zuverlässigkeit">
            <a:extLst>
              <a:ext uri="{FF2B5EF4-FFF2-40B4-BE49-F238E27FC236}">
                <a16:creationId xmlns:a16="http://schemas.microsoft.com/office/drawing/2014/main" id="{A8D9685C-90D8-24DC-E9DE-59E43B1FA89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76750" y="1809750"/>
            <a:ext cx="3238500" cy="3238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59681037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2406B5E-F6F1-2F4C-F934-1CA314305A0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>
            <a:extLst>
              <a:ext uri="{FF2B5EF4-FFF2-40B4-BE49-F238E27FC236}">
                <a16:creationId xmlns:a16="http://schemas.microsoft.com/office/drawing/2014/main" id="{B7B24BBC-A429-5B2B-60CD-0BEA863923AA}"/>
              </a:ext>
            </a:extLst>
          </p:cNvPr>
          <p:cNvSpPr txBox="1"/>
          <p:nvPr/>
        </p:nvSpPr>
        <p:spPr>
          <a:xfrm>
            <a:off x="0" y="6379501"/>
            <a:ext cx="12192000" cy="4648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SM-Fig. 24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Dental alginate “</a:t>
            </a:r>
            <a:r>
              <a:rPr lang="en-US" sz="18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ropicalgin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” (thickness 0.05 cm, perpendicular shot, 10 m distance) </a:t>
            </a:r>
            <a:endParaRPr lang="de-DE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Grafik 2" descr="Ein Bild, das Gelände enthält.&#10;&#10;Automatisch generierte Beschreibung mit mittlerer Zuverlässigkeit">
            <a:extLst>
              <a:ext uri="{FF2B5EF4-FFF2-40B4-BE49-F238E27FC236}">
                <a16:creationId xmlns:a16="http://schemas.microsoft.com/office/drawing/2014/main" id="{46BD630A-EA89-5A85-BFBC-88C1D8BCCA4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07000" y="1625600"/>
            <a:ext cx="3238500" cy="3238500"/>
          </a:xfrm>
          <a:prstGeom prst="rect">
            <a:avLst/>
          </a:prstGeom>
        </p:spPr>
      </p:pic>
      <p:pic>
        <p:nvPicPr>
          <p:cNvPr id="4" name="Grafik 3">
            <a:extLst>
              <a:ext uri="{FF2B5EF4-FFF2-40B4-BE49-F238E27FC236}">
                <a16:creationId xmlns:a16="http://schemas.microsoft.com/office/drawing/2014/main" id="{7E8BBA9E-8DE8-F2A8-34B4-8E87A6B920D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68687" y="801687"/>
            <a:ext cx="5254626" cy="52546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1269872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FD0EAA2-9436-D5A0-37D5-E74084539D5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>
            <a:extLst>
              <a:ext uri="{FF2B5EF4-FFF2-40B4-BE49-F238E27FC236}">
                <a16:creationId xmlns:a16="http://schemas.microsoft.com/office/drawing/2014/main" id="{FE698FB9-909D-A704-0726-8818E485E03E}"/>
              </a:ext>
            </a:extLst>
          </p:cNvPr>
          <p:cNvSpPr txBox="1"/>
          <p:nvPr/>
        </p:nvSpPr>
        <p:spPr>
          <a:xfrm>
            <a:off x="0" y="6379501"/>
            <a:ext cx="12192000" cy="4648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SM-Fig. 25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Medical suture trainer (exemplary, perpendicular shot, 10 m distance) </a:t>
            </a:r>
            <a:endParaRPr lang="de-DE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7" name="Grafik 6" descr="Ein Bild, das Lineal, Messstab Maßband enthält.&#10;&#10;Automatisch generierte Beschreibung">
            <a:extLst>
              <a:ext uri="{FF2B5EF4-FFF2-40B4-BE49-F238E27FC236}">
                <a16:creationId xmlns:a16="http://schemas.microsoft.com/office/drawing/2014/main" id="{CB4A4D6E-4778-90BD-2D7A-5F10A404B7E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19599" y="1752599"/>
            <a:ext cx="3352801" cy="33528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711225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BA85247-8C71-3E22-7FC8-3192F6898AE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87E7FF25-E6A1-C28B-81F1-370444A3EE9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21864" b="21072"/>
          <a:stretch/>
        </p:blipFill>
        <p:spPr>
          <a:xfrm>
            <a:off x="3287711" y="622311"/>
            <a:ext cx="5616575" cy="5613377"/>
          </a:xfrm>
          <a:prstGeom prst="rect">
            <a:avLst/>
          </a:prstGeom>
        </p:spPr>
      </p:pic>
      <p:sp>
        <p:nvSpPr>
          <p:cNvPr id="8" name="Textfeld 7">
            <a:extLst>
              <a:ext uri="{FF2B5EF4-FFF2-40B4-BE49-F238E27FC236}">
                <a16:creationId xmlns:a16="http://schemas.microsoft.com/office/drawing/2014/main" id="{E7CDAE38-13B4-B56B-D5A6-B44764C0CAE1}"/>
              </a:ext>
            </a:extLst>
          </p:cNvPr>
          <p:cNvSpPr txBox="1"/>
          <p:nvPr/>
        </p:nvSpPr>
        <p:spPr>
          <a:xfrm>
            <a:off x="-1" y="6393129"/>
            <a:ext cx="12192000" cy="4648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SM-Fig. 3 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elatine 20 % by mass (thickness 0.3 cm, perpendicular shot, 10 m distance)  </a:t>
            </a:r>
            <a:endParaRPr lang="de-DE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986765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3F04F54-CBBE-6FB4-7D23-3B69D6B6F3D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 descr="Ein Bild, das Messstab Maßband enthält.&#10;&#10;Automatisch generierte Beschreibung mit mittlerer Zuverlässigkeit">
            <a:extLst>
              <a:ext uri="{FF2B5EF4-FFF2-40B4-BE49-F238E27FC236}">
                <a16:creationId xmlns:a16="http://schemas.microsoft.com/office/drawing/2014/main" id="{A0A891C8-857B-40E6-D298-A62BB1D5FCC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097282" y="395696"/>
            <a:ext cx="5997433" cy="5997433"/>
          </a:xfrm>
          <a:prstGeom prst="rect">
            <a:avLst/>
          </a:prstGeom>
        </p:spPr>
      </p:pic>
      <p:sp>
        <p:nvSpPr>
          <p:cNvPr id="6" name="Textfeld 5">
            <a:extLst>
              <a:ext uri="{FF2B5EF4-FFF2-40B4-BE49-F238E27FC236}">
                <a16:creationId xmlns:a16="http://schemas.microsoft.com/office/drawing/2014/main" id="{8B6F4B4A-1850-02E6-E801-C8F06ADA132D}"/>
              </a:ext>
            </a:extLst>
          </p:cNvPr>
          <p:cNvSpPr txBox="1"/>
          <p:nvPr/>
        </p:nvSpPr>
        <p:spPr>
          <a:xfrm>
            <a:off x="-1" y="6393129"/>
            <a:ext cx="12192000" cy="4648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SM-Fig. </a:t>
            </a:r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4</a:t>
            </a:r>
            <a:r>
              <a:rPr lang="en-US" sz="18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elatine 20 % by mass (thickness 0.6 cm, oblique shot, 0.3 m distance) </a:t>
            </a:r>
            <a:endParaRPr lang="de-DE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5580105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7A1A8E3-9C4E-3A82-CC93-CA2591D7AD2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Grafik 5" descr="Ein Bild, das Wirbellose, Insekt, Messstab Maßband enthält.&#10;&#10;Automatisch generierte Beschreibung">
            <a:extLst>
              <a:ext uri="{FF2B5EF4-FFF2-40B4-BE49-F238E27FC236}">
                <a16:creationId xmlns:a16="http://schemas.microsoft.com/office/drawing/2014/main" id="{1D4A721F-B21C-FE20-E0BA-9A092B500AD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77233" y="1810234"/>
            <a:ext cx="3237531" cy="3237531"/>
          </a:xfrm>
          <a:prstGeom prst="rect">
            <a:avLst/>
          </a:prstGeom>
        </p:spPr>
      </p:pic>
      <p:sp>
        <p:nvSpPr>
          <p:cNvPr id="7" name="Textfeld 6">
            <a:extLst>
              <a:ext uri="{FF2B5EF4-FFF2-40B4-BE49-F238E27FC236}">
                <a16:creationId xmlns:a16="http://schemas.microsoft.com/office/drawing/2014/main" id="{FEBEA0B7-2C2D-C6E4-866C-6A53C1FF4717}"/>
              </a:ext>
            </a:extLst>
          </p:cNvPr>
          <p:cNvSpPr txBox="1"/>
          <p:nvPr/>
        </p:nvSpPr>
        <p:spPr>
          <a:xfrm>
            <a:off x="-1" y="6393129"/>
            <a:ext cx="12192000" cy="4648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SM-Fig. 5 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elatine 30 % by mass (thickness 0.3 cm, perpendicular shot, 10 m distance)</a:t>
            </a:r>
            <a:endParaRPr lang="de-DE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6225205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80886B2-4DC3-3D17-39B8-62ED7336235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 descr="Ein Bild, das Lineal, Messstab Maßband enthält.&#10;&#10;Automatisch generierte Beschreibung">
            <a:extLst>
              <a:ext uri="{FF2B5EF4-FFF2-40B4-BE49-F238E27FC236}">
                <a16:creationId xmlns:a16="http://schemas.microsoft.com/office/drawing/2014/main" id="{9A1D7D20-6BCF-BF7F-9251-8A6C1C3F841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03184" y="1429143"/>
            <a:ext cx="3985629" cy="3999713"/>
          </a:xfrm>
          <a:prstGeom prst="rect">
            <a:avLst/>
          </a:prstGeom>
        </p:spPr>
      </p:pic>
      <p:sp>
        <p:nvSpPr>
          <p:cNvPr id="9" name="Textfeld 8">
            <a:extLst>
              <a:ext uri="{FF2B5EF4-FFF2-40B4-BE49-F238E27FC236}">
                <a16:creationId xmlns:a16="http://schemas.microsoft.com/office/drawing/2014/main" id="{C9BC486B-E07D-3AB6-38E2-56098A32BFB3}"/>
              </a:ext>
            </a:extLst>
          </p:cNvPr>
          <p:cNvSpPr txBox="1"/>
          <p:nvPr/>
        </p:nvSpPr>
        <p:spPr>
          <a:xfrm>
            <a:off x="-1" y="6393129"/>
            <a:ext cx="12192000" cy="4648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SM-Fig. </a:t>
            </a:r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6</a:t>
            </a:r>
            <a:r>
              <a:rPr lang="en-US" sz="18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elatine 30 % by mass (thickness 0.6 cm, oblique shot, 0.3 m distance)</a:t>
            </a:r>
            <a:endParaRPr lang="de-DE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5615093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3513661-51F4-7C85-5FC0-1004151624F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Grafik 7">
            <a:extLst>
              <a:ext uri="{FF2B5EF4-FFF2-40B4-BE49-F238E27FC236}">
                <a16:creationId xmlns:a16="http://schemas.microsoft.com/office/drawing/2014/main" id="{AF86DB16-192C-D249-2568-1C94D9557A5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60686" y="993687"/>
            <a:ext cx="4870626" cy="4870626"/>
          </a:xfrm>
          <a:prstGeom prst="rect">
            <a:avLst/>
          </a:prstGeom>
        </p:spPr>
      </p:pic>
      <p:sp>
        <p:nvSpPr>
          <p:cNvPr id="9" name="Textfeld 8">
            <a:extLst>
              <a:ext uri="{FF2B5EF4-FFF2-40B4-BE49-F238E27FC236}">
                <a16:creationId xmlns:a16="http://schemas.microsoft.com/office/drawing/2014/main" id="{3224BA2C-2DAA-824A-77D2-7172B0EEB028}"/>
              </a:ext>
            </a:extLst>
          </p:cNvPr>
          <p:cNvSpPr txBox="1"/>
          <p:nvPr/>
        </p:nvSpPr>
        <p:spPr>
          <a:xfrm>
            <a:off x="-1" y="6393129"/>
            <a:ext cx="12192000" cy="4648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SM-Fig. 7 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elatine 40 % by mass (thickness 0.6 cm, oblique shot, 0.3 m distance) </a:t>
            </a:r>
            <a:endParaRPr lang="de-DE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3374904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F1BD640-BBDC-568A-6B5D-765B38E35C5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feld 8">
            <a:extLst>
              <a:ext uri="{FF2B5EF4-FFF2-40B4-BE49-F238E27FC236}">
                <a16:creationId xmlns:a16="http://schemas.microsoft.com/office/drawing/2014/main" id="{7602654F-83D8-DBF8-629B-CB225FDCCD5F}"/>
              </a:ext>
            </a:extLst>
          </p:cNvPr>
          <p:cNvSpPr txBox="1"/>
          <p:nvPr/>
        </p:nvSpPr>
        <p:spPr>
          <a:xfrm>
            <a:off x="-1" y="6393129"/>
            <a:ext cx="12192000" cy="4648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SM-Fig. </a:t>
            </a:r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8</a:t>
            </a:r>
            <a:r>
              <a:rPr lang="en-US" sz="18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elatine 50 % by mass (thickness 0.3 cm, perpendicular shot, 10 m distance)</a:t>
            </a:r>
            <a:endParaRPr lang="de-DE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Grafik 2" descr="Ein Bild, das Insekt, Wirbellose, gelb, Messstab Maßband enthält.&#10;&#10;Automatisch generierte Beschreibung">
            <a:extLst>
              <a:ext uri="{FF2B5EF4-FFF2-40B4-BE49-F238E27FC236}">
                <a16:creationId xmlns:a16="http://schemas.microsoft.com/office/drawing/2014/main" id="{B40E5C68-27D7-18F4-74D0-919B0933DF6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22655" y="1155656"/>
            <a:ext cx="4546688" cy="45466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6650719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B27CE1C-1AB9-AA45-5FFA-FC56D992AD3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feld 8">
            <a:extLst>
              <a:ext uri="{FF2B5EF4-FFF2-40B4-BE49-F238E27FC236}">
                <a16:creationId xmlns:a16="http://schemas.microsoft.com/office/drawing/2014/main" id="{4B630473-4D9E-20B9-9F0B-76C253C5565D}"/>
              </a:ext>
            </a:extLst>
          </p:cNvPr>
          <p:cNvSpPr txBox="1"/>
          <p:nvPr/>
        </p:nvSpPr>
        <p:spPr>
          <a:xfrm>
            <a:off x="-1" y="6393129"/>
            <a:ext cx="12192000" cy="4648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SM-Fig. 9 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elatine 50 % by mass (thickness 0.6 cm, oblique shot, 0.3 m distance) </a:t>
            </a:r>
            <a:endParaRPr lang="de-DE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Grafik 3" descr="Ein Bild, das Wirbellose enthält.&#10;&#10;Automatisch generierte Beschreibung">
            <a:extLst>
              <a:ext uri="{FF2B5EF4-FFF2-40B4-BE49-F238E27FC236}">
                <a16:creationId xmlns:a16="http://schemas.microsoft.com/office/drawing/2014/main" id="{31BC3038-A80C-4205-0D81-7406704A7AE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80681" y="1113682"/>
            <a:ext cx="4630636" cy="46306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095314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76</Words>
  <Application>Microsoft Macintosh PowerPoint</Application>
  <PresentationFormat>Breitbild</PresentationFormat>
  <Paragraphs>25</Paragraphs>
  <Slides>25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5</vt:i4>
      </vt:variant>
    </vt:vector>
  </HeadingPairs>
  <TitlesOfParts>
    <vt:vector size="29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Victoria Fischer</dc:creator>
  <cp:lastModifiedBy>Victoria Fischer</cp:lastModifiedBy>
  <cp:revision>20</cp:revision>
  <dcterms:created xsi:type="dcterms:W3CDTF">2024-02-12T18:10:40Z</dcterms:created>
  <dcterms:modified xsi:type="dcterms:W3CDTF">2024-03-14T20:08:54Z</dcterms:modified>
</cp:coreProperties>
</file>